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94568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4" d="100"/>
          <a:sy n="84" d="100"/>
        </p:scale>
        <p:origin x="1402" y="5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6D65A9-0783-41A2-A6CF-32B39D1C03BC}" type="datetimeFigureOut">
              <a:rPr lang="ko-KR" altLang="en-US" smtClean="0"/>
              <a:t>2020-11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B11D60-C8CA-437A-A735-33BC25C355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924283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6D65A9-0783-41A2-A6CF-32B39D1C03BC}" type="datetimeFigureOut">
              <a:rPr lang="ko-KR" altLang="en-US" smtClean="0"/>
              <a:t>2020-11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B11D60-C8CA-437A-A735-33BC25C355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35388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6D65A9-0783-41A2-A6CF-32B39D1C03BC}" type="datetimeFigureOut">
              <a:rPr lang="ko-KR" altLang="en-US" smtClean="0"/>
              <a:t>2020-11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B11D60-C8CA-437A-A735-33BC25C355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127236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6D65A9-0783-41A2-A6CF-32B39D1C03BC}" type="datetimeFigureOut">
              <a:rPr lang="ko-KR" altLang="en-US" smtClean="0"/>
              <a:t>2020-11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B11D60-C8CA-437A-A735-33BC25C355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386286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6D65A9-0783-41A2-A6CF-32B39D1C03BC}" type="datetimeFigureOut">
              <a:rPr lang="ko-KR" altLang="en-US" smtClean="0"/>
              <a:t>2020-11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B11D60-C8CA-437A-A735-33BC25C355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297461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6D65A9-0783-41A2-A6CF-32B39D1C03BC}" type="datetimeFigureOut">
              <a:rPr lang="ko-KR" altLang="en-US" smtClean="0"/>
              <a:t>2020-11-1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B11D60-C8CA-437A-A735-33BC25C355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505308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6D65A9-0783-41A2-A6CF-32B39D1C03BC}" type="datetimeFigureOut">
              <a:rPr lang="ko-KR" altLang="en-US" smtClean="0"/>
              <a:t>2020-11-12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B11D60-C8CA-437A-A735-33BC25C355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515688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6D65A9-0783-41A2-A6CF-32B39D1C03BC}" type="datetimeFigureOut">
              <a:rPr lang="ko-KR" altLang="en-US" smtClean="0"/>
              <a:t>2020-11-12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B11D60-C8CA-437A-A735-33BC25C355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241843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6D65A9-0783-41A2-A6CF-32B39D1C03BC}" type="datetimeFigureOut">
              <a:rPr lang="ko-KR" altLang="en-US" smtClean="0"/>
              <a:t>2020-11-12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B11D60-C8CA-437A-A735-33BC25C355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549671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6D65A9-0783-41A2-A6CF-32B39D1C03BC}" type="datetimeFigureOut">
              <a:rPr lang="ko-KR" altLang="en-US" smtClean="0"/>
              <a:t>2020-11-1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B11D60-C8CA-437A-A735-33BC25C355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991986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6D65A9-0783-41A2-A6CF-32B39D1C03BC}" type="datetimeFigureOut">
              <a:rPr lang="ko-KR" altLang="en-US" smtClean="0"/>
              <a:t>2020-11-1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B11D60-C8CA-437A-A735-33BC25C355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069886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6D65A9-0783-41A2-A6CF-32B39D1C03BC}" type="datetimeFigureOut">
              <a:rPr lang="ko-KR" altLang="en-US" smtClean="0"/>
              <a:t>2020-11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B11D60-C8CA-437A-A735-33BC25C355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438166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개체 1">
            <a:extLst>
              <a:ext uri="{FF2B5EF4-FFF2-40B4-BE49-F238E27FC236}">
                <a16:creationId xmlns:a16="http://schemas.microsoft.com/office/drawing/2014/main" xmlns="" id="{113C9E48-F85E-458C-A424-D37F1518DDA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67304543"/>
              </p:ext>
            </p:extLst>
          </p:nvPr>
        </p:nvGraphicFramePr>
        <p:xfrm>
          <a:off x="2411760" y="476673"/>
          <a:ext cx="4248472" cy="348981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4" name="Prism 5" r:id="rId3" imgW="3452040" imgH="3200400" progId="Prism5.Document">
                  <p:embed/>
                </p:oleObj>
              </mc:Choice>
              <mc:Fallback>
                <p:oleObj name="Prism 5" r:id="rId3" imgW="3452040" imgH="32004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411760" y="476673"/>
                        <a:ext cx="4248472" cy="348981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5FC6A4F2-9E33-4656-8D62-C2CA4E97FB23}"/>
              </a:ext>
            </a:extLst>
          </p:cNvPr>
          <p:cNvSpPr txBox="1"/>
          <p:nvPr/>
        </p:nvSpPr>
        <p:spPr>
          <a:xfrm>
            <a:off x="2123728" y="44624"/>
            <a:ext cx="4608512" cy="307777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60 min in the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dark without gain test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before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dark rearing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표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72196026"/>
              </p:ext>
            </p:extLst>
          </p:nvPr>
        </p:nvGraphicFramePr>
        <p:xfrm>
          <a:off x="1547664" y="4001472"/>
          <a:ext cx="6096000" cy="25958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16000"/>
                <a:gridCol w="1016000"/>
                <a:gridCol w="1016000"/>
                <a:gridCol w="1016000"/>
                <a:gridCol w="1016000"/>
                <a:gridCol w="1016000"/>
              </a:tblGrid>
              <a:tr h="370840">
                <a:tc>
                  <a:txBody>
                    <a:bodyPr/>
                    <a:lstStyle/>
                    <a:p>
                      <a:pPr algn="ctr" fontAlgn="b"/>
                      <a:endParaRPr lang="ko-KR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b="1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/>
                        </a:rPr>
                        <a:t>60 min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b="1" i="0" u="none" strike="noStrike">
                          <a:solidFill>
                            <a:srgbClr val="FF0000"/>
                          </a:solidFill>
                          <a:effectLst/>
                          <a:latin typeface="Times New Roman"/>
                        </a:rPr>
                        <a:t>A 1 hr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b="1" i="0" u="none" strike="noStrike">
                          <a:solidFill>
                            <a:srgbClr val="FF0000"/>
                          </a:solidFill>
                          <a:effectLst/>
                          <a:latin typeface="Times New Roman"/>
                        </a:rPr>
                        <a:t>A 3hr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b="1" i="0" u="none" strike="noStrike">
                          <a:solidFill>
                            <a:srgbClr val="FF0000"/>
                          </a:solidFill>
                          <a:effectLst/>
                          <a:latin typeface="Times New Roman"/>
                        </a:rPr>
                        <a:t>A 24 hr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b="1" i="0" u="none" strike="noStrike">
                          <a:solidFill>
                            <a:srgbClr val="FF0000"/>
                          </a:solidFill>
                          <a:effectLst/>
                          <a:latin typeface="Times New Roman"/>
                        </a:rPr>
                        <a:t>A 48hr</a:t>
                      </a:r>
                    </a:p>
                  </a:txBody>
                  <a:tcPr marL="7620" marR="7620" marT="7620" marB="0" anchor="b"/>
                </a:tc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_1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96</a:t>
                      </a:r>
                      <a:endParaRPr lang="en-US" altLang="ko-KR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38</a:t>
                      </a:r>
                      <a:endParaRPr lang="en-US" altLang="ko-KR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34</a:t>
                      </a:r>
                      <a:endParaRPr lang="en-US" altLang="ko-KR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58</a:t>
                      </a:r>
                      <a:endParaRPr lang="en-US" altLang="ko-KR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18</a:t>
                      </a:r>
                    </a:p>
                  </a:txBody>
                  <a:tcPr marL="7620" marR="7620" marT="7620" marB="0" anchor="b"/>
                </a:tc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_2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73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51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85</a:t>
                      </a:r>
                      <a:endParaRPr lang="en-US" altLang="ko-KR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84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50</a:t>
                      </a:r>
                      <a:endParaRPr lang="en-US" altLang="ko-KR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_3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89</a:t>
                      </a:r>
                      <a:endParaRPr lang="en-US" altLang="ko-KR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47</a:t>
                      </a:r>
                      <a:endParaRPr lang="en-US" altLang="ko-KR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61</a:t>
                      </a:r>
                      <a:endParaRPr lang="en-US" altLang="ko-KR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82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52</a:t>
                      </a:r>
                      <a:endParaRPr lang="en-US" altLang="ko-KR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_4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10</a:t>
                      </a:r>
                      <a:endParaRPr lang="en-US" altLang="ko-KR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57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89</a:t>
                      </a:r>
                      <a:endParaRPr lang="en-US" altLang="ko-KR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39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75</a:t>
                      </a:r>
                      <a:endParaRPr lang="en-US" altLang="ko-KR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4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17</a:t>
                      </a:r>
                      <a:endParaRPr lang="en-US" altLang="ko-KR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4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73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4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92</a:t>
                      </a:r>
                      <a:endParaRPr lang="en-US" altLang="ko-KR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4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91</a:t>
                      </a:r>
                      <a:endParaRPr lang="en-US" altLang="ko-KR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4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74</a:t>
                      </a:r>
                      <a:endParaRPr lang="en-US" altLang="ko-KR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4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3</a:t>
                      </a:r>
                      <a:endParaRPr lang="en-US" altLang="ko-KR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4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2</a:t>
                      </a:r>
                      <a:endParaRPr lang="en-US" altLang="ko-KR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4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5</a:t>
                      </a:r>
                      <a:endParaRPr lang="en-US" altLang="ko-KR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4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5</a:t>
                      </a:r>
                      <a:endParaRPr lang="en-US" altLang="ko-KR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400" b="1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2</a:t>
                      </a:r>
                      <a:endParaRPr lang="en-US" altLang="ko-KR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087908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81</TotalTime>
  <Words>60</Words>
  <Application>Microsoft Office PowerPoint</Application>
  <PresentationFormat>On-screen Show (4:3)</PresentationFormat>
  <Paragraphs>42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Times New Roman</vt:lpstr>
      <vt:lpstr>Office 테마</vt:lpstr>
      <vt:lpstr>Prism 5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User</dc:creator>
  <cp:lastModifiedBy>Naveen Kumar</cp:lastModifiedBy>
  <cp:revision>3</cp:revision>
  <cp:lastPrinted>2020-10-05T07:05:53Z</cp:lastPrinted>
  <dcterms:created xsi:type="dcterms:W3CDTF">2020-10-05T06:56:21Z</dcterms:created>
  <dcterms:modified xsi:type="dcterms:W3CDTF">2020-11-12T08:22:21Z</dcterms:modified>
</cp:coreProperties>
</file>